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314A88-9D02-42E0-891D-64D960C9DF0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680FD4-73B5-490F-8371-701FA60E7D4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3A7BAD-3541-4785-8DE5-D9954FF721C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D1682C-DB24-4FE6-A349-F8D592B9D5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B0C9B1-95AF-4B32-8F55-4F1179FA10A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BA8EDA-68D9-4822-9552-E74369906933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C6E1F-E25A-4FEB-957C-CF666FB3041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3F2C6-F33B-4503-A434-0A76B0D0B59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A231C3-DCE4-4A07-83C2-40310C49DAB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947F9-F80A-4C34-B422-2B4F9DEDE6F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0D596E-D6BC-48A2-8C5E-EE267ED8272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fld id="{2C5B7070-85AC-4AC6-A406-85AA7B734B3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9728852"/>
              </p:ext>
            </p:extLst>
          </p:nvPr>
        </p:nvGraphicFramePr>
        <p:xfrm>
          <a:off x="1" y="344488"/>
          <a:ext cx="6857999" cy="1535850"/>
        </p:xfrm>
        <a:graphic>
          <a:graphicData uri="http://schemas.openxmlformats.org/drawingml/2006/table">
            <a:tbl>
              <a:tblPr/>
              <a:tblGrid>
                <a:gridCol w="1120427"/>
                <a:gridCol w="363988"/>
                <a:gridCol w="3588288"/>
                <a:gridCol w="1785296"/>
              </a:tblGrid>
              <a:tr h="170650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081" marR="11081" marT="110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ptide sequences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mble No. or Genbank no.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cs-CZ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uman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YADAIFTNSYRKVLGQLSARKLLQDIMSRQQGESNQERGARARL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P00000237527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use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VDAIFTTNYRKLLSQLYARKVIQDIMNKQGERIQEQRARLSRQ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MUP000000029172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icken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ADAIFTDNYRKFLGQISARKFLQTII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GALP00000006088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es-ES_tradnl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ole</a:t>
                      </a:r>
                      <a:r>
                        <a:rPr lang="es-ES_trad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s-ES_tradnl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zard</a:t>
                      </a:r>
                      <a:endParaRPr lang="es-ES_tradnl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ADAIFTDSYRKVRGKLSAQKLLQGIV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ACAP00000011587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enopus Laevis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VDAIFTNTYRKFLGQISARRYLQNMM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P_001090197.1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elacanth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ADALFTNSYRKVLGQISARKFLQTIM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LACP00000010877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oldfish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ADAIFTNSYRKVLGQISARKFLQTVM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BJ55977.1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065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Zebrafish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HRH</a:t>
                      </a:r>
                    </a:p>
                  </a:txBody>
                  <a:tcPr marL="11081" marR="11081" marT="1108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ourier"/>
                        </a:rPr>
                        <a:t>HADAIFTNSYRKVLGQISARKFLQTVM</a:t>
                      </a:r>
                    </a:p>
                  </a:txBody>
                  <a:tcPr marL="11081" marR="11081" marT="110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SDARP00000091949</a:t>
                      </a:r>
                    </a:p>
                  </a:txBody>
                  <a:tcPr marL="11081" marR="11081" marT="110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 Box 4"/>
          <p:cNvSpPr txBox="1">
            <a:spLocks noChangeArrowheads="1"/>
          </p:cNvSpPr>
          <p:nvPr/>
        </p:nvSpPr>
        <p:spPr bwMode="auto">
          <a:xfrm>
            <a:off x="-22225" y="-15552"/>
            <a:ext cx="1579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400" b="1" dirty="0" smtClean="0">
                <a:ea typeface="新細明體" pitchFamily="18" charset="-120"/>
              </a:rPr>
              <a:t>FIGURE S7</a:t>
            </a:r>
            <a:endParaRPr lang="en-US" altLang="zh-TW" sz="1400" b="1" dirty="0">
              <a:ea typeface="新細明體" pitchFamily="18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647984076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3</TotalTime>
  <Words>45</Words>
  <Application>Microsoft Macintosh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3:02:57Z</dcterms:modified>
</cp:coreProperties>
</file>